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4A503-91BC-4562-970B-5062F90966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A1B90-AFF5-4FA4-A5CE-5A5ED25DE4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8C37F-4DDE-4FFD-BD3D-F6914B849A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F36E5-7CAD-4E7E-AF9B-7CE34A1CD8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75583-151A-45A5-AEC5-520F38C35F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E2F5B9-34C4-4396-9566-42648FC426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BBE54-9A51-4D83-9ED0-99DBFE0EE5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3B494-5297-4C6E-9287-5F09DBB1C6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7B30D-0655-4528-87CD-946AFE61EC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9BD90-E941-49EA-BEAA-5CB0092079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14C8C-F3CB-4875-A553-B726F68F6D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23CA8-E933-4120-A3A9-F61D9D4E00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AF3CA3-2605-496E-966B-D2C855CBFE5B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adroTexto 9"/>
          <p:cNvSpPr/>
          <p:nvPr/>
        </p:nvSpPr>
        <p:spPr>
          <a:xfrm>
            <a:off x="1052640" y="798480"/>
            <a:ext cx="576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CuadroTexto 10"/>
          <p:cNvSpPr/>
          <p:nvPr/>
        </p:nvSpPr>
        <p:spPr>
          <a:xfrm>
            <a:off x="1052640" y="3533760"/>
            <a:ext cx="576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CuadroTexto 11"/>
          <p:cNvSpPr/>
          <p:nvPr/>
        </p:nvSpPr>
        <p:spPr>
          <a:xfrm>
            <a:off x="1052640" y="6199200"/>
            <a:ext cx="576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2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CuadroTexto 12"/>
          <p:cNvSpPr/>
          <p:nvPr/>
        </p:nvSpPr>
        <p:spPr>
          <a:xfrm>
            <a:off x="115920" y="108000"/>
            <a:ext cx="66261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Times New Roman"/>
              </a:rPr>
              <a:t>Sup Fig 4. Individual changes in plasma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hesperitin-7-b-D-glucuronide after: A, control; B, oranje juice (OJ); and C, enriched OJ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CuadroTexto 13"/>
          <p:cNvSpPr/>
          <p:nvPr/>
        </p:nvSpPr>
        <p:spPr>
          <a:xfrm>
            <a:off x="1065240" y="826920"/>
            <a:ext cx="203040" cy="2305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CuadroTexto 21"/>
          <p:cNvSpPr/>
          <p:nvPr/>
        </p:nvSpPr>
        <p:spPr>
          <a:xfrm>
            <a:off x="752400" y="4046400"/>
            <a:ext cx="15552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haroni"/>
                <a:ea typeface="Aharoni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CuadroTexto 23"/>
          <p:cNvSpPr/>
          <p:nvPr/>
        </p:nvSpPr>
        <p:spPr>
          <a:xfrm>
            <a:off x="752400" y="5127480"/>
            <a:ext cx="15552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haroni"/>
                <a:ea typeface="Aharoni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CuadroTexto 27"/>
          <p:cNvSpPr/>
          <p:nvPr/>
        </p:nvSpPr>
        <p:spPr>
          <a:xfrm>
            <a:off x="760320" y="7543800"/>
            <a:ext cx="2271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haroni"/>
                <a:ea typeface="Aharoni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9" name="Grupo 1"/>
          <p:cNvGrpSpPr/>
          <p:nvPr/>
        </p:nvGrpSpPr>
        <p:grpSpPr>
          <a:xfrm>
            <a:off x="284040" y="760320"/>
            <a:ext cx="6193080" cy="8132760"/>
            <a:chOff x="284040" y="760320"/>
            <a:chExt cx="6193080" cy="8132760"/>
          </a:xfrm>
        </p:grpSpPr>
        <p:pic>
          <p:nvPicPr>
            <p:cNvPr id="50" name="Imagen 3" descr=""/>
            <p:cNvPicPr/>
            <p:nvPr/>
          </p:nvPicPr>
          <p:blipFill>
            <a:blip r:embed="rId1"/>
            <a:stretch/>
          </p:blipFill>
          <p:spPr>
            <a:xfrm>
              <a:off x="452160" y="3495600"/>
              <a:ext cx="5856840" cy="287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Imagen 4" descr=""/>
            <p:cNvPicPr/>
            <p:nvPr/>
          </p:nvPicPr>
          <p:blipFill>
            <a:blip r:embed="rId2"/>
            <a:stretch/>
          </p:blipFill>
          <p:spPr>
            <a:xfrm>
              <a:off x="380880" y="6222960"/>
              <a:ext cx="6096240" cy="267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CuadroTexto 7"/>
            <p:cNvSpPr/>
            <p:nvPr/>
          </p:nvSpPr>
          <p:spPr>
            <a:xfrm rot="16200000">
              <a:off x="-270000" y="4464000"/>
              <a:ext cx="17902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Times New Roman"/>
                </a:rPr>
                <a:t>Change</a:t>
              </a:r>
              <a:r>
                <a:rPr b="1" lang="es-ES" sz="1200" spc="-1" strike="noStrike">
                  <a:solidFill>
                    <a:srgbClr val="000000"/>
                  </a:solidFill>
                  <a:latin typeface="Times New Roman"/>
                </a:rPr>
                <a:t> (log), nmol/L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CuadroTexto 8"/>
            <p:cNvSpPr/>
            <p:nvPr/>
          </p:nvSpPr>
          <p:spPr>
            <a:xfrm rot="16200000">
              <a:off x="-417960" y="7213680"/>
              <a:ext cx="208800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Times New Roman"/>
                </a:rPr>
                <a:t>Change  (log), nmol/L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4" name="Grupo 19"/>
            <p:cNvGrpSpPr/>
            <p:nvPr/>
          </p:nvGrpSpPr>
          <p:grpSpPr>
            <a:xfrm>
              <a:off x="284040" y="760320"/>
              <a:ext cx="5953680" cy="2874960"/>
              <a:chOff x="284040" y="760320"/>
              <a:chExt cx="5953680" cy="2874960"/>
            </a:xfrm>
          </p:grpSpPr>
          <p:pic>
            <p:nvPicPr>
              <p:cNvPr id="55" name="Imagen 5" descr=""/>
              <p:cNvPicPr/>
              <p:nvPr/>
            </p:nvPicPr>
            <p:blipFill>
              <a:blip r:embed="rId3"/>
              <a:stretch/>
            </p:blipFill>
            <p:spPr>
              <a:xfrm>
                <a:off x="284040" y="760320"/>
                <a:ext cx="5953680" cy="2874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CuadroTexto 6"/>
              <p:cNvSpPr/>
              <p:nvPr/>
            </p:nvSpPr>
            <p:spPr>
              <a:xfrm rot="16200000">
                <a:off x="-399600" y="1714680"/>
                <a:ext cx="1907280" cy="276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Times New Roman"/>
                  </a:rPr>
                  <a:t>Change</a:t>
                </a:r>
                <a:r>
                  <a:rPr b="1" lang="es-ES" sz="1200" spc="-1" strike="noStrike">
                    <a:solidFill>
                      <a:srgbClr val="000000"/>
                    </a:solidFill>
                    <a:latin typeface="Times New Roman"/>
                  </a:rPr>
                  <a:t> (log), nmol/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CuadroTexto 15"/>
              <p:cNvSpPr/>
              <p:nvPr/>
            </p:nvSpPr>
            <p:spPr>
              <a:xfrm>
                <a:off x="692280" y="797400"/>
                <a:ext cx="21600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900" spc="-1" strike="noStrike">
                    <a:solidFill>
                      <a:srgbClr val="000000"/>
                    </a:solidFill>
                    <a:latin typeface="Aharoni"/>
                    <a:ea typeface="Aharoni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CuadroTexto 16"/>
              <p:cNvSpPr/>
              <p:nvPr/>
            </p:nvSpPr>
            <p:spPr>
              <a:xfrm>
                <a:off x="692280" y="1517400"/>
                <a:ext cx="21600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900" spc="-1" strike="noStrike">
                    <a:solidFill>
                      <a:srgbClr val="000000"/>
                    </a:solidFill>
                    <a:latin typeface="Aharoni"/>
                    <a:ea typeface="Aharoni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CuadroTexto 17"/>
              <p:cNvSpPr/>
              <p:nvPr/>
            </p:nvSpPr>
            <p:spPr>
              <a:xfrm>
                <a:off x="631440" y="2237400"/>
                <a:ext cx="276840" cy="368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900" spc="-1" strike="noStrike">
                    <a:solidFill>
                      <a:srgbClr val="000000"/>
                    </a:solidFill>
                    <a:latin typeface="Aharoni"/>
                    <a:ea typeface="Aharoni"/>
                  </a:rPr>
                  <a:t>-1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CuadroTexto 18"/>
              <p:cNvSpPr/>
              <p:nvPr/>
            </p:nvSpPr>
            <p:spPr>
              <a:xfrm>
                <a:off x="630000" y="2957400"/>
                <a:ext cx="276840" cy="368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900" spc="-1" strike="noStrike">
                    <a:solidFill>
                      <a:srgbClr val="000000"/>
                    </a:solidFill>
                    <a:latin typeface="Aharoni"/>
                    <a:ea typeface="Aharoni"/>
                  </a:rPr>
                  <a:t>-2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61" name="CuadroTexto 20"/>
            <p:cNvSpPr/>
            <p:nvPr/>
          </p:nvSpPr>
          <p:spPr>
            <a:xfrm>
              <a:off x="752040" y="3533760"/>
              <a:ext cx="15552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haroni"/>
                  <a:ea typeface="Aharoni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CuadroTexto 22"/>
            <p:cNvSpPr/>
            <p:nvPr/>
          </p:nvSpPr>
          <p:spPr>
            <a:xfrm>
              <a:off x="752040" y="4600440"/>
              <a:ext cx="15552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haroni"/>
                  <a:ea typeface="Aharoni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CuadroTexto 25"/>
            <p:cNvSpPr/>
            <p:nvPr/>
          </p:nvSpPr>
          <p:spPr>
            <a:xfrm>
              <a:off x="620280" y="5694480"/>
              <a:ext cx="27936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haroni"/>
                  <a:ea typeface="Aharoni"/>
                </a:rPr>
                <a:t>-1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CuadroTexto 26"/>
            <p:cNvSpPr/>
            <p:nvPr/>
          </p:nvSpPr>
          <p:spPr>
            <a:xfrm>
              <a:off x="752040" y="6673680"/>
              <a:ext cx="22860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haroni"/>
                  <a:ea typeface="Aharoni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CuadroTexto 28"/>
            <p:cNvSpPr/>
            <p:nvPr/>
          </p:nvSpPr>
          <p:spPr>
            <a:xfrm>
              <a:off x="765000" y="7524720"/>
              <a:ext cx="22680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haroni"/>
                  <a:ea typeface="Aharoni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CuadroTexto 29"/>
            <p:cNvSpPr/>
            <p:nvPr/>
          </p:nvSpPr>
          <p:spPr>
            <a:xfrm>
              <a:off x="760320" y="8388360"/>
              <a:ext cx="22680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haroni"/>
                  <a:ea typeface="Aharoni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7" name="CuadroTexto 1"/>
          <p:cNvSpPr/>
          <p:nvPr/>
        </p:nvSpPr>
        <p:spPr>
          <a:xfrm>
            <a:off x="117360" y="1604880"/>
            <a:ext cx="26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CuadroTexto 28"/>
          <p:cNvSpPr/>
          <p:nvPr/>
        </p:nvSpPr>
        <p:spPr>
          <a:xfrm>
            <a:off x="198360" y="4287960"/>
            <a:ext cx="26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CuadroTexto 29"/>
          <p:cNvSpPr/>
          <p:nvPr/>
        </p:nvSpPr>
        <p:spPr>
          <a:xfrm>
            <a:off x="249120" y="7155000"/>
            <a:ext cx="26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11-27T11:55:00Z</dcterms:created>
  <dc:creator>UPF</dc:creator>
  <dc:description/>
  <dc:language>en-US</dc:language>
  <cp:lastModifiedBy>Anna Pedret</cp:lastModifiedBy>
  <dcterms:modified xsi:type="dcterms:W3CDTF">2020-04-02T18:41:17Z</dcterms:modified>
  <cp:revision>47</cp:revision>
  <dc:subject/>
  <dc:title>Presentación de PowerPoint</dc:title>
</cp:coreProperties>
</file>